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media/image6.pct" ContentType="image/x-pict"/>
  <Override PartName="/ppt/media/image7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67ED6-CB1B-457F-B5B5-B9CF079CEB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DD5E4-3C9F-4764-922B-983B23608E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AD32D-B312-4045-93A4-05F5BF4954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AA097-4129-4C2A-8AFC-18BAFEDFCB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FE86D-FC87-4C9F-8809-221F9E1102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59E38-BA23-46B4-928D-A1C4578F2F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EB4AE-1412-4354-A588-636A6ACF81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A187B-8243-4BBE-A6BE-A437A442A4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1BE31-1E78-47E9-8751-B533796D08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9442B-0FFA-4CF8-99C4-1A39432B58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DF2B8-0F18-47F0-8828-F23318BF75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F1479-AC5E-465C-874E-DE968C0A0C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44452F-7EAA-46B2-80E1-915C42F22470}" type="slidenum">
              <a:rPr b="0" lang="es-ES_trad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ct"/><Relationship Id="rId2" Type="http://schemas.openxmlformats.org/officeDocument/2006/relationships/image" Target="../media/image3.pct"/><Relationship Id="rId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ct"/><Relationship Id="rId2" Type="http://schemas.openxmlformats.org/officeDocument/2006/relationships/image" Target="../media/image5.pct"/><Relationship Id="rId3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ct"/><Relationship Id="rId2" Type="http://schemas.openxmlformats.org/officeDocument/2006/relationships/image" Target="../media/image7.pct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58680" y="762120"/>
            <a:ext cx="9202680" cy="5113080"/>
            <a:chOff x="-58680" y="762120"/>
            <a:chExt cx="9202680" cy="511308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76320" y="838080"/>
              <a:ext cx="8980200" cy="503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2895480" y="4114800"/>
              <a:ext cx="1447920" cy="22860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362320" y="4114800"/>
              <a:ext cx="2514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400" spc="-1" strike="noStrike">
                  <a:solidFill>
                    <a:srgbClr val="000000"/>
                  </a:solidFill>
                  <a:latin typeface="Arial"/>
                </a:rPr>
                <a:t>Position in </a:t>
              </a:r>
              <a:r>
                <a:rPr b="1" i="1" lang="es-ES_tradnl" sz="1400" spc="-1" strike="noStrike">
                  <a:solidFill>
                    <a:srgbClr val="000000"/>
                  </a:solidFill>
                  <a:latin typeface="Arial"/>
                </a:rPr>
                <a:t>repA</a:t>
              </a:r>
              <a:r>
                <a:rPr b="1" lang="es-ES_tradnl" sz="1400" spc="-1" strike="noStrike">
                  <a:solidFill>
                    <a:srgbClr val="000000"/>
                  </a:solidFill>
                  <a:latin typeface="Arial"/>
                </a:rPr>
                <a:t> alignm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0" y="762120"/>
              <a:ext cx="228600" cy="2514600"/>
            </a:xfrm>
            <a:custGeom>
              <a:avLst/>
              <a:gdLst>
                <a:gd name="textAreaLeft" fmla="*/ 11160 w 228600"/>
                <a:gd name="textAreaRight" fmla="*/ 217440 w 228600"/>
                <a:gd name="textAreaTop" fmla="*/ 11160 h 2514600"/>
                <a:gd name="textAreaBottom" fmla="*/ 2503440 h 2514600"/>
              </a:gdLst>
              <a:ahLst/>
              <a:rect l="textAreaLeft" t="textAreaTop" r="textAreaRight" b="textAreaBottom"/>
              <a:pathLst>
                <a:path w="21600" h="237260">
                  <a:moveTo>
                    <a:pt x="3600" y="0"/>
                  </a:moveTo>
                  <a:arcTo wR="3600" hR="3600" stAng="16200000" swAng="-5400000"/>
                  <a:lnTo>
                    <a:pt x="0" y="233660"/>
                  </a:lnTo>
                  <a:arcTo wR="3600" hR="3600" stAng="10800000" swAng="-5400000"/>
                  <a:lnTo>
                    <a:pt x="18000" y="237260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-968400" y="1882800"/>
              <a:ext cx="212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400" spc="-1" strike="noStrike">
                  <a:solidFill>
                    <a:srgbClr val="000000"/>
                  </a:solidFill>
                  <a:latin typeface="Arial"/>
                </a:rPr>
                <a:t>Pairwise identi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400800" y="1371600"/>
              <a:ext cx="2743200" cy="914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371600" y="1219320"/>
              <a:ext cx="51055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019920" y="1444680"/>
              <a:ext cx="3124080" cy="69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6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f3c9d9"/>
                  </a:solidFill>
                  <a:latin typeface="Arial"/>
                </a:rPr>
                <a:t>[]</a:t>
              </a: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 Tract of recombin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6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fffd2e"/>
                  </a:solidFill>
                  <a:latin typeface="Arial"/>
                </a:rPr>
                <a:t>-- </a:t>
              </a: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Dshibae_pDSH04-Rsphaeroides_p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6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bd43d9"/>
                  </a:solidFill>
                  <a:latin typeface="Arial"/>
                </a:rPr>
                <a:t>-- </a:t>
              </a: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Dshibae_pDSH04-Rlegum_pRL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6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9999"/>
                  </a:solidFill>
                  <a:latin typeface="Arial"/>
                </a:rPr>
                <a:t>-- </a:t>
              </a: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Rsphaeroides_pB-Rlegum_pRL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"/>
          <p:cNvGrpSpPr/>
          <p:nvPr/>
        </p:nvGrpSpPr>
        <p:grpSpPr>
          <a:xfrm>
            <a:off x="-76320" y="-76320"/>
            <a:ext cx="10515600" cy="8229600"/>
            <a:chOff x="-76320" y="-76320"/>
            <a:chExt cx="10515600" cy="8229600"/>
          </a:xfrm>
        </p:grpSpPr>
        <p:grpSp>
          <p:nvGrpSpPr>
            <p:cNvPr id="51" name=""/>
            <p:cNvGrpSpPr/>
            <p:nvPr/>
          </p:nvGrpSpPr>
          <p:grpSpPr>
            <a:xfrm>
              <a:off x="-76320" y="-76320"/>
              <a:ext cx="10515600" cy="8229600"/>
              <a:chOff x="-76320" y="-76320"/>
              <a:chExt cx="10515600" cy="8229600"/>
            </a:xfrm>
          </p:grpSpPr>
          <p:grpSp>
            <p:nvGrpSpPr>
              <p:cNvPr id="52" name=""/>
              <p:cNvGrpSpPr/>
              <p:nvPr/>
            </p:nvGrpSpPr>
            <p:grpSpPr>
              <a:xfrm>
                <a:off x="0" y="-76320"/>
                <a:ext cx="9144000" cy="8229600"/>
                <a:chOff x="0" y="-76320"/>
                <a:chExt cx="9144000" cy="8229600"/>
              </a:xfrm>
            </p:grpSpPr>
            <p:pic>
              <p:nvPicPr>
                <p:cNvPr id="53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11160" y="-76320"/>
                  <a:ext cx="9132840" cy="5122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4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0" y="3024000"/>
                  <a:ext cx="9144000" cy="51292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55" name=""/>
              <p:cNvSpPr/>
              <p:nvPr/>
            </p:nvSpPr>
            <p:spPr>
              <a:xfrm>
                <a:off x="0" y="-76320"/>
                <a:ext cx="152280" cy="5638680"/>
              </a:xfrm>
              <a:custGeom>
                <a:avLst/>
                <a:gdLst>
                  <a:gd name="textAreaLeft" fmla="*/ 7200 w 152280"/>
                  <a:gd name="textAreaRight" fmla="*/ 145080 w 152280"/>
                  <a:gd name="textAreaTop" fmla="*/ 7200 h 5638680"/>
                  <a:gd name="textAreaBottom" fmla="*/ 5631480 h 5638680"/>
                </a:gdLst>
                <a:ahLst/>
                <a:rect l="textAreaLeft" t="textAreaTop" r="textAreaRight" b="textAreaBottom"/>
                <a:pathLst>
                  <a:path w="21600" h="797977">
                    <a:moveTo>
                      <a:pt x="3600" y="0"/>
                    </a:moveTo>
                    <a:arcTo wR="3600" hR="3600" stAng="16200000" swAng="-5400000"/>
                    <a:lnTo>
                      <a:pt x="0" y="794377"/>
                    </a:lnTo>
                    <a:arcTo wR="3600" hR="3600" stAng="10800000" swAng="-5400000"/>
                    <a:lnTo>
                      <a:pt x="18000" y="797977"/>
                    </a:lnTo>
                    <a:arcTo wR="3600" hR="3600" stAng="5400000" swAng="-5400000"/>
                    <a:lnTo>
                      <a:pt x="21600" y="3600"/>
                    </a:lnTo>
                    <a:arcTo wR="3600" hR="3600" stAng="0" swAng="-5400000"/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2743200" y="6324480"/>
                <a:ext cx="1828800" cy="304920"/>
              </a:xfrm>
              <a:prstGeom prst="roundRect">
                <a:avLst>
                  <a:gd name="adj" fmla="val 16667"/>
                </a:avLst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438280" y="6324480"/>
                <a:ext cx="259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osition in </a:t>
                </a:r>
                <a:r>
                  <a:rPr b="1" i="1" lang="es-ES_tradnl" sz="1400" spc="-1" strike="noStrike">
                    <a:solidFill>
                      <a:srgbClr val="000000"/>
                    </a:solidFill>
                    <a:latin typeface="Arial"/>
                  </a:rPr>
                  <a:t>repB </a:t>
                </a: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alignmen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rot="16200000">
                <a:off x="-951120" y="4148280"/>
                <a:ext cx="2057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airwise identit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rot="16200000">
                <a:off x="-952200" y="1172520"/>
                <a:ext cx="2059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airwise identit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6553080" y="3504960"/>
                <a:ext cx="2590920" cy="914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6476760" y="3504960"/>
                <a:ext cx="3962520" cy="69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3-Rlegum_pRL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3-Retli_p42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legum_pRL7-Retlip42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6553080" y="457200"/>
                <a:ext cx="2590920" cy="914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6324480" y="533160"/>
                <a:ext cx="3124080" cy="69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legum_pRL12-Oanthropi_pOANT0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legum_pRL12-Oanthropi_pOANT0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Oanthropi_pOANT03-Oanthropi_pOANT0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4" name=""/>
            <p:cNvSpPr/>
            <p:nvPr/>
          </p:nvSpPr>
          <p:spPr>
            <a:xfrm>
              <a:off x="1218960" y="152280"/>
              <a:ext cx="525780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295280" y="3352680"/>
              <a:ext cx="525780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"/>
          <p:cNvGrpSpPr/>
          <p:nvPr/>
        </p:nvGrpSpPr>
        <p:grpSpPr>
          <a:xfrm>
            <a:off x="-76320" y="0"/>
            <a:ext cx="9829800" cy="8077320"/>
            <a:chOff x="-76320" y="0"/>
            <a:chExt cx="9829800" cy="8077320"/>
          </a:xfrm>
        </p:grpSpPr>
        <p:pic>
          <p:nvPicPr>
            <p:cNvPr id="67" name="" descr=""/>
            <p:cNvPicPr/>
            <p:nvPr/>
          </p:nvPicPr>
          <p:blipFill>
            <a:blip r:embed="rId1"/>
            <a:stretch/>
          </p:blipFill>
          <p:spPr>
            <a:xfrm>
              <a:off x="0" y="2948040"/>
              <a:ext cx="9144000" cy="5129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8" name=""/>
            <p:cNvGrpSpPr/>
            <p:nvPr/>
          </p:nvGrpSpPr>
          <p:grpSpPr>
            <a:xfrm>
              <a:off x="-76320" y="0"/>
              <a:ext cx="9829800" cy="6586560"/>
              <a:chOff x="-76320" y="0"/>
              <a:chExt cx="9829800" cy="6586560"/>
            </a:xfrm>
          </p:grpSpPr>
          <p:sp>
            <p:nvSpPr>
              <p:cNvPr id="69" name=""/>
              <p:cNvSpPr/>
              <p:nvPr/>
            </p:nvSpPr>
            <p:spPr>
              <a:xfrm>
                <a:off x="6629400" y="738360"/>
                <a:ext cx="3124080" cy="86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be0e3"/>
                    </a:solidFill>
                    <a:latin typeface="Arial"/>
                  </a:rPr>
                  <a:t>[]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ites excluded from analys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sphaeroides_pB-Retli_p42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sphaeroides_pB-Msp.BNC1_p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etli_p42f-Msp.BNC1_p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0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0" y="52560"/>
                <a:ext cx="9067680" cy="5086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1" name=""/>
              <p:cNvSpPr/>
              <p:nvPr/>
            </p:nvSpPr>
            <p:spPr>
              <a:xfrm>
                <a:off x="990720" y="457200"/>
                <a:ext cx="5257800" cy="304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838080" y="3386160"/>
                <a:ext cx="5410440" cy="228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0" y="0"/>
                <a:ext cx="228600" cy="5867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590920" y="6281640"/>
                <a:ext cx="2361960" cy="304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6477120" y="3462480"/>
                <a:ext cx="2666880" cy="838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6477120" y="3691080"/>
                <a:ext cx="2666880" cy="69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sphaeroides_pB-Retli_p42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sphaeroides_pB-Msp.BNC1_p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etli_p42f-Msp.BNC1_p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6629400" y="566640"/>
                <a:ext cx="2514600" cy="1143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rot="16200000">
                <a:off x="-955800" y="1203480"/>
                <a:ext cx="2070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airwise identit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rot="16200000">
                <a:off x="-956880" y="4101480"/>
                <a:ext cx="2068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airwise identit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590920" y="6205680"/>
                <a:ext cx="2514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osition in </a:t>
                </a:r>
                <a:r>
                  <a:rPr b="1" i="1" lang="es-ES_tradnl" sz="1400" spc="-1" strike="noStrike">
                    <a:solidFill>
                      <a:srgbClr val="000000"/>
                    </a:solidFill>
                    <a:latin typeface="Arial"/>
                  </a:rPr>
                  <a:t>repC</a:t>
                </a: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 alignmen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6477120" y="666720"/>
                <a:ext cx="3124080" cy="86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be0e3"/>
                    </a:solidFill>
                    <a:latin typeface="Arial"/>
                  </a:rPr>
                  <a:t>[]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ites excluded from analys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Oanthropi_chromoII-Mloti_pML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Mloti_pMLa-Rsphaeroids_p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Oanthropi_chromoII-Rsphaeroids_p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"/>
          <p:cNvGrpSpPr/>
          <p:nvPr/>
        </p:nvGrpSpPr>
        <p:grpSpPr>
          <a:xfrm>
            <a:off x="-76320" y="52560"/>
            <a:ext cx="9906120" cy="8100360"/>
            <a:chOff x="-76320" y="52560"/>
            <a:chExt cx="9906120" cy="8100360"/>
          </a:xfrm>
        </p:grpSpPr>
        <p:pic>
          <p:nvPicPr>
            <p:cNvPr id="83" name="" descr=""/>
            <p:cNvPicPr/>
            <p:nvPr/>
          </p:nvPicPr>
          <p:blipFill>
            <a:blip r:embed="rId1"/>
            <a:stretch/>
          </p:blipFill>
          <p:spPr>
            <a:xfrm>
              <a:off x="0" y="3024000"/>
              <a:ext cx="9144000" cy="5128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4" name=""/>
            <p:cNvGrpSpPr/>
            <p:nvPr/>
          </p:nvGrpSpPr>
          <p:grpSpPr>
            <a:xfrm>
              <a:off x="-76320" y="52560"/>
              <a:ext cx="9906120" cy="6631200"/>
              <a:chOff x="-76320" y="52560"/>
              <a:chExt cx="9906120" cy="6631200"/>
            </a:xfrm>
          </p:grpSpPr>
          <p:pic>
            <p:nvPicPr>
              <p:cNvPr id="85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0" y="52560"/>
                <a:ext cx="9144000" cy="5128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"/>
              <p:cNvSpPr/>
              <p:nvPr/>
            </p:nvSpPr>
            <p:spPr>
              <a:xfrm>
                <a:off x="0" y="52560"/>
                <a:ext cx="228600" cy="5866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838080" y="357120"/>
                <a:ext cx="5410440" cy="304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914400" y="3328920"/>
                <a:ext cx="5410080" cy="304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133720" y="6376680"/>
                <a:ext cx="3124080" cy="3045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362320" y="6376680"/>
                <a:ext cx="2514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osition in </a:t>
                </a:r>
                <a:r>
                  <a:rPr b="1" i="1" lang="es-ES_tradnl" sz="1400" spc="-1" strike="noStrike">
                    <a:solidFill>
                      <a:srgbClr val="000000"/>
                    </a:solidFill>
                    <a:latin typeface="Arial"/>
                  </a:rPr>
                  <a:t>repC</a:t>
                </a: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 alignmen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 rot="16200000">
                <a:off x="-957240" y="1082520"/>
                <a:ext cx="2069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airwise identit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rot="16200000">
                <a:off x="-966960" y="3995640"/>
                <a:ext cx="208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400" spc="-1" strike="noStrike">
                    <a:solidFill>
                      <a:srgbClr val="000000"/>
                    </a:solidFill>
                    <a:latin typeface="Arial"/>
                  </a:rPr>
                  <a:t>Pairwise identity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6629400" y="585720"/>
                <a:ext cx="2514600" cy="9140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6472080" y="718920"/>
                <a:ext cx="3357720" cy="86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-Smedicae_pSMED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3-Retli_p42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1-Retli_p42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6629400" y="3481200"/>
                <a:ext cx="2514600" cy="1142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6477120" y="3674880"/>
                <a:ext cx="3124080" cy="1036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be0e3"/>
                    </a:solidFill>
                    <a:latin typeface="Arial"/>
                  </a:rPr>
                  <a:t>[]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ites excluded from analys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3c9d9"/>
                    </a:solidFill>
                    <a:latin typeface="Arial"/>
                  </a:rPr>
                  <a:t>[]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Tract of recombin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fffd2e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2-Rlegum_pRL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bd43d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Smedicae_pSMED0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-Bmeltns16M_chromI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6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_tradnl" sz="1000" spc="-1" strike="noStrike">
                    <a:solidFill>
                      <a:srgbClr val="009999"/>
                    </a:solidFill>
                    <a:latin typeface="Arial"/>
                  </a:rPr>
                  <a:t>-- </a:t>
                </a:r>
                <a:r>
                  <a:rPr b="1" lang="es-ES_tradnl" sz="1000" spc="-1" strike="noStrike">
                    <a:solidFill>
                      <a:srgbClr val="000000"/>
                    </a:solidFill>
                    <a:latin typeface="Arial"/>
                  </a:rPr>
                  <a:t>Rlegum_pRL8-Bmeltns16M_chromoI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1T21:03:43Z</dcterms:created>
  <dc:creator>Santiago  Castillo Ramirez</dc:creator>
  <dc:description/>
  <dc:language>en-US</dc:language>
  <cp:lastModifiedBy>Santiago  Castillo Ramirez</cp:lastModifiedBy>
  <dcterms:modified xsi:type="dcterms:W3CDTF">2009-03-17T19:45:07Z</dcterms:modified>
  <cp:revision>30</cp:revision>
  <dc:subject/>
  <dc:title>Presentación de PowerPoint</dc:title>
</cp:coreProperties>
</file>